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9" autoAdjust="0"/>
    <p:restoredTop sz="94660"/>
  </p:normalViewPr>
  <p:slideViewPr>
    <p:cSldViewPr snapToGrid="0">
      <p:cViewPr varScale="1">
        <p:scale>
          <a:sx n="67" d="100"/>
          <a:sy n="67" d="100"/>
        </p:scale>
        <p:origin x="172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008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999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143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145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269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51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031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986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69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601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467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76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04268AA6-C5D6-4194-B20F-CE6D8DCBE58A}"/>
              </a:ext>
            </a:extLst>
          </p:cNvPr>
          <p:cNvSpPr/>
          <p:nvPr/>
        </p:nvSpPr>
        <p:spPr>
          <a:xfrm>
            <a:off x="205740" y="8085322"/>
            <a:ext cx="630936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 S3. Histological images of the lungs at day</a:t>
            </a:r>
            <a:r>
              <a:rPr lang="ja-JP" alt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 of infection in C57BL/6 mice by hematoxylin-eosin staining. Bars indicate 50 </a:t>
            </a:r>
            <a:r>
              <a:rPr lang="en-US" altLang="ja-JP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F15D828D-206C-451D-8054-DAC4A49C7A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440" y="265081"/>
            <a:ext cx="6639119" cy="64135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4422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7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eishi</dc:creator>
  <cp:lastModifiedBy>Tateishi</cp:lastModifiedBy>
  <cp:revision>5</cp:revision>
  <dcterms:created xsi:type="dcterms:W3CDTF">2022-12-07T03:50:42Z</dcterms:created>
  <dcterms:modified xsi:type="dcterms:W3CDTF">2022-12-07T06:44:57Z</dcterms:modified>
</cp:coreProperties>
</file>